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56" r:id="rId3"/>
    <p:sldId id="258" r:id="rId4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1" d="100"/>
          <a:sy n="71" d="100"/>
        </p:scale>
        <p:origin x="486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E28615-0A6A-4F39-9EBA-CC5C419BA0C6}" type="datetimeFigureOut">
              <a:rPr lang="zh-CN" altLang="en-US" smtClean="0"/>
              <a:t>2020-10-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B88FB9-B4A4-470A-9F72-C4FC560A608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353713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E28615-0A6A-4F39-9EBA-CC5C419BA0C6}" type="datetimeFigureOut">
              <a:rPr lang="zh-CN" altLang="en-US" smtClean="0"/>
              <a:t>2020-10-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B88FB9-B4A4-470A-9F72-C4FC560A608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205750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E28615-0A6A-4F39-9EBA-CC5C419BA0C6}" type="datetimeFigureOut">
              <a:rPr lang="zh-CN" altLang="en-US" smtClean="0"/>
              <a:t>2020-10-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B88FB9-B4A4-470A-9F72-C4FC560A608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095139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E28615-0A6A-4F39-9EBA-CC5C419BA0C6}" type="datetimeFigureOut">
              <a:rPr lang="zh-CN" altLang="en-US" smtClean="0"/>
              <a:t>2020-10-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B88FB9-B4A4-470A-9F72-C4FC560A608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290068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E28615-0A6A-4F39-9EBA-CC5C419BA0C6}" type="datetimeFigureOut">
              <a:rPr lang="zh-CN" altLang="en-US" smtClean="0"/>
              <a:t>2020-10-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B88FB9-B4A4-470A-9F72-C4FC560A608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34711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E28615-0A6A-4F39-9EBA-CC5C419BA0C6}" type="datetimeFigureOut">
              <a:rPr lang="zh-CN" altLang="en-US" smtClean="0"/>
              <a:t>2020-10-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B88FB9-B4A4-470A-9F72-C4FC560A608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019002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E28615-0A6A-4F39-9EBA-CC5C419BA0C6}" type="datetimeFigureOut">
              <a:rPr lang="zh-CN" altLang="en-US" smtClean="0"/>
              <a:t>2020-10-8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B88FB9-B4A4-470A-9F72-C4FC560A608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046949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E28615-0A6A-4F39-9EBA-CC5C419BA0C6}" type="datetimeFigureOut">
              <a:rPr lang="zh-CN" altLang="en-US" smtClean="0"/>
              <a:t>2020-10-8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B88FB9-B4A4-470A-9F72-C4FC560A608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907603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E28615-0A6A-4F39-9EBA-CC5C419BA0C6}" type="datetimeFigureOut">
              <a:rPr lang="zh-CN" altLang="en-US" smtClean="0"/>
              <a:t>2020-10-8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B88FB9-B4A4-470A-9F72-C4FC560A608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788082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E28615-0A6A-4F39-9EBA-CC5C419BA0C6}" type="datetimeFigureOut">
              <a:rPr lang="zh-CN" altLang="en-US" smtClean="0"/>
              <a:t>2020-10-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B88FB9-B4A4-470A-9F72-C4FC560A608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661405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E28615-0A6A-4F39-9EBA-CC5C419BA0C6}" type="datetimeFigureOut">
              <a:rPr lang="zh-CN" altLang="en-US" smtClean="0"/>
              <a:t>2020-10-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B88FB9-B4A4-470A-9F72-C4FC560A608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740034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E28615-0A6A-4F39-9EBA-CC5C419BA0C6}" type="datetimeFigureOut">
              <a:rPr lang="zh-CN" altLang="en-US" smtClean="0"/>
              <a:t>2020-10-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B88FB9-B4A4-470A-9F72-C4FC560A608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609310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282" t="40345" r="39202" b="47660"/>
          <a:stretch/>
        </p:blipFill>
        <p:spPr>
          <a:xfrm>
            <a:off x="3214251" y="5187478"/>
            <a:ext cx="1846168" cy="55133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" name="图片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214250" y="2447364"/>
            <a:ext cx="1846169" cy="267852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" name="文本框 4"/>
          <p:cNvSpPr txBox="1"/>
          <p:nvPr/>
        </p:nvSpPr>
        <p:spPr>
          <a:xfrm>
            <a:off x="2299445" y="2123558"/>
            <a:ext cx="113204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EGF (min)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3446927" y="2110111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3787585" y="2123558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2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4074455" y="2123558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5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4307537" y="2123558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1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4621301" y="2123558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3</a:t>
            </a:r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3574273" y="1699548"/>
            <a:ext cx="120898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Replicate </a:t>
            </a:r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1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2237697" y="1388454"/>
            <a:ext cx="367351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HeLa: APEX2-FLAG-STS1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13" name="直接连接符 12"/>
          <p:cNvCxnSpPr/>
          <p:nvPr/>
        </p:nvCxnSpPr>
        <p:spPr>
          <a:xfrm>
            <a:off x="3431485" y="2060806"/>
            <a:ext cx="1512000" cy="8964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" name="文本框 13"/>
          <p:cNvSpPr txBox="1"/>
          <p:nvPr/>
        </p:nvSpPr>
        <p:spPr>
          <a:xfrm>
            <a:off x="5060419" y="3509683"/>
            <a:ext cx="79337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4G1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5060419" y="5131852"/>
            <a:ext cx="250115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nti-FLAG</a:t>
            </a:r>
          </a:p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(APEX2-FLAG-STS1)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295835" y="295835"/>
            <a:ext cx="39805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Supplementary figure 6a. Replicate 1</a:t>
            </a:r>
            <a:endParaRPr lang="zh-CN" altLang="en-US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2609131" y="2664378"/>
            <a:ext cx="5261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18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20" name="直接连接符 19"/>
          <p:cNvCxnSpPr/>
          <p:nvPr/>
        </p:nvCxnSpPr>
        <p:spPr>
          <a:xfrm>
            <a:off x="3106271" y="2840732"/>
            <a:ext cx="10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" name="文本框 21"/>
          <p:cNvSpPr txBox="1"/>
          <p:nvPr/>
        </p:nvSpPr>
        <p:spPr>
          <a:xfrm>
            <a:off x="2613614" y="2870566"/>
            <a:ext cx="5261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13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23" name="直接连接符 22"/>
          <p:cNvCxnSpPr/>
          <p:nvPr/>
        </p:nvCxnSpPr>
        <p:spPr>
          <a:xfrm>
            <a:off x="3110754" y="3046920"/>
            <a:ext cx="10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" name="文本框 23"/>
          <p:cNvSpPr txBox="1"/>
          <p:nvPr/>
        </p:nvSpPr>
        <p:spPr>
          <a:xfrm>
            <a:off x="2613614" y="3179847"/>
            <a:ext cx="5261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10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25" name="直接连接符 24"/>
          <p:cNvCxnSpPr/>
          <p:nvPr/>
        </p:nvCxnSpPr>
        <p:spPr>
          <a:xfrm>
            <a:off x="3110754" y="3356201"/>
            <a:ext cx="10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6" name="文本框 25"/>
          <p:cNvSpPr txBox="1"/>
          <p:nvPr/>
        </p:nvSpPr>
        <p:spPr>
          <a:xfrm>
            <a:off x="2725673" y="3507058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7</a:t>
            </a:r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27" name="直接连接符 26"/>
          <p:cNvCxnSpPr/>
          <p:nvPr/>
        </p:nvCxnSpPr>
        <p:spPr>
          <a:xfrm>
            <a:off x="3101790" y="3656518"/>
            <a:ext cx="10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" name="文本框 27"/>
          <p:cNvSpPr txBox="1"/>
          <p:nvPr/>
        </p:nvSpPr>
        <p:spPr>
          <a:xfrm>
            <a:off x="2716709" y="3914951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55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29" name="直接连接符 28"/>
          <p:cNvCxnSpPr/>
          <p:nvPr/>
        </p:nvCxnSpPr>
        <p:spPr>
          <a:xfrm>
            <a:off x="3106273" y="4064411"/>
            <a:ext cx="10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" name="文本框 29"/>
          <p:cNvSpPr txBox="1"/>
          <p:nvPr/>
        </p:nvSpPr>
        <p:spPr>
          <a:xfrm>
            <a:off x="2734639" y="4322844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4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31" name="直接连接符 30"/>
          <p:cNvCxnSpPr/>
          <p:nvPr/>
        </p:nvCxnSpPr>
        <p:spPr>
          <a:xfrm>
            <a:off x="3124203" y="4472304"/>
            <a:ext cx="10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2" name="文本框 31"/>
          <p:cNvSpPr txBox="1"/>
          <p:nvPr/>
        </p:nvSpPr>
        <p:spPr>
          <a:xfrm>
            <a:off x="2591203" y="5376196"/>
            <a:ext cx="5261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10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33" name="直接连接符 32"/>
          <p:cNvCxnSpPr/>
          <p:nvPr/>
        </p:nvCxnSpPr>
        <p:spPr>
          <a:xfrm>
            <a:off x="3088343" y="5552550"/>
            <a:ext cx="10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0330454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735" t="17010" r="13606" b="28352"/>
          <a:stretch/>
        </p:blipFill>
        <p:spPr>
          <a:xfrm flipH="1">
            <a:off x="2541494" y="2595283"/>
            <a:ext cx="3684494" cy="285077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图片 5"/>
          <p:cNvPicPr>
            <a:picLocks noChangeAspect="1"/>
          </p:cNvPicPr>
          <p:nvPr/>
        </p:nvPicPr>
        <p:blipFill rotWithShape="1">
          <a:blip r:embed="rId3"/>
          <a:srcRect t="11168" b="26037"/>
          <a:stretch/>
        </p:blipFill>
        <p:spPr>
          <a:xfrm>
            <a:off x="2541494" y="5526741"/>
            <a:ext cx="3684494" cy="55133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" name="文本框 6"/>
          <p:cNvSpPr txBox="1"/>
          <p:nvPr/>
        </p:nvSpPr>
        <p:spPr>
          <a:xfrm>
            <a:off x="6225988" y="4020671"/>
            <a:ext cx="79337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4G1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6225987" y="5510145"/>
            <a:ext cx="250115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nti-FLAG</a:t>
            </a:r>
          </a:p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(APEX2-FLAG-STS1)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1721226" y="2217688"/>
            <a:ext cx="113204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EGF (min)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2828367" y="2217688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1" name="文本框 10"/>
          <p:cNvSpPr txBox="1"/>
          <p:nvPr/>
        </p:nvSpPr>
        <p:spPr>
          <a:xfrm>
            <a:off x="3142131" y="2217688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2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2" name="文本框 11"/>
          <p:cNvSpPr txBox="1"/>
          <p:nvPr/>
        </p:nvSpPr>
        <p:spPr>
          <a:xfrm>
            <a:off x="3455895" y="2217688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5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3715871" y="2217688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1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4043082" y="2217688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3</a:t>
            </a:r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4433044" y="2208724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4746808" y="2208724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2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5060572" y="2208724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5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5320548" y="2208724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1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5647759" y="2208724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3</a:t>
            </a:r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0" name="文本框 19"/>
          <p:cNvSpPr txBox="1"/>
          <p:nvPr/>
        </p:nvSpPr>
        <p:spPr>
          <a:xfrm>
            <a:off x="2996054" y="1726443"/>
            <a:ext cx="120898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Replicate 2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1" name="文本框 20"/>
          <p:cNvSpPr txBox="1"/>
          <p:nvPr/>
        </p:nvSpPr>
        <p:spPr>
          <a:xfrm>
            <a:off x="4637395" y="1743195"/>
            <a:ext cx="120898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Replicate 3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2" name="文本框 21"/>
          <p:cNvSpPr txBox="1"/>
          <p:nvPr/>
        </p:nvSpPr>
        <p:spPr>
          <a:xfrm>
            <a:off x="2578275" y="1307536"/>
            <a:ext cx="367351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HeLa: APEX2-FLAG-STS1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24" name="直接连接符 23"/>
          <p:cNvCxnSpPr/>
          <p:nvPr/>
        </p:nvCxnSpPr>
        <p:spPr>
          <a:xfrm>
            <a:off x="2853266" y="2154936"/>
            <a:ext cx="1512000" cy="8964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5" name="直接连接符 24"/>
          <p:cNvCxnSpPr/>
          <p:nvPr/>
        </p:nvCxnSpPr>
        <p:spPr>
          <a:xfrm>
            <a:off x="4484836" y="2145972"/>
            <a:ext cx="1512000" cy="8964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" name="文本框 22"/>
          <p:cNvSpPr txBox="1"/>
          <p:nvPr/>
        </p:nvSpPr>
        <p:spPr>
          <a:xfrm>
            <a:off x="295835" y="295835"/>
            <a:ext cx="46217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Supplementary figure 6a. Replicate 2 and 3</a:t>
            </a:r>
            <a:endParaRPr lang="zh-CN" altLang="en-US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35449440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48415" y="2474259"/>
            <a:ext cx="4220276" cy="3254188"/>
          </a:xfrm>
          <a:prstGeom prst="rect">
            <a:avLst/>
          </a:prstGeom>
        </p:spPr>
      </p:pic>
      <p:sp>
        <p:nvSpPr>
          <p:cNvPr id="3" name="矩形 2"/>
          <p:cNvSpPr/>
          <p:nvPr/>
        </p:nvSpPr>
        <p:spPr>
          <a:xfrm>
            <a:off x="240780" y="1321404"/>
            <a:ext cx="491031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Supplementary figure 6a</a:t>
            </a:r>
            <a:r>
              <a:rPr lang="en-US" altLang="zh-CN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. Quantification (n=3) 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4606702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1</TotalTime>
  <Words>74</Words>
  <Application>Microsoft Office PowerPoint</Application>
  <PresentationFormat>全屏显示(4:3)</PresentationFormat>
  <Paragraphs>38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9" baseType="lpstr">
      <vt:lpstr>Arial Unicode MS</vt:lpstr>
      <vt:lpstr>宋体</vt:lpstr>
      <vt:lpstr>Arial</vt:lpstr>
      <vt:lpstr>Calibri</vt:lpstr>
      <vt:lpstr>Calibri Light</vt:lpstr>
      <vt:lpstr>Office 主题</vt:lpstr>
      <vt:lpstr>PowerPoint 演示文稿</vt:lpstr>
      <vt:lpstr>PowerPoint 演示文稿</vt:lpstr>
      <vt:lpstr>PowerPoint 演示文稿</vt:lpstr>
    </vt:vector>
  </TitlesOfParts>
  <Company>SUSTC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indows 用户</dc:creator>
  <cp:lastModifiedBy>Windows 用户</cp:lastModifiedBy>
  <cp:revision>7</cp:revision>
  <dcterms:created xsi:type="dcterms:W3CDTF">2020-08-31T02:42:53Z</dcterms:created>
  <dcterms:modified xsi:type="dcterms:W3CDTF">2020-10-08T07:21:04Z</dcterms:modified>
</cp:coreProperties>
</file>